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Στυλ κύριου υπότιτλ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72665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64453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612660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5872473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927822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67615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137379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20756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39365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90791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Στυλ κύριου τίτλου</a:t>
            </a:r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45346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Στυλ κύριου τίτλου</a:t>
            </a:r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υποδείγματος κειμένου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23AB7-0E05-469C-B284-BA17A7992F71}" type="datetimeFigureOut">
              <a:rPr lang="el-GR" smtClean="0"/>
              <a:t>9/8/2021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32EE7-7DA1-4E72-8423-FA199057BD0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12051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Ομάδα 17"/>
          <p:cNvGrpSpPr/>
          <p:nvPr/>
        </p:nvGrpSpPr>
        <p:grpSpPr>
          <a:xfrm>
            <a:off x="237222" y="416859"/>
            <a:ext cx="11814988" cy="4462533"/>
            <a:chOff x="237222" y="416859"/>
            <a:chExt cx="11814988" cy="4462533"/>
          </a:xfrm>
        </p:grpSpPr>
        <p:graphicFrame>
          <p:nvGraphicFramePr>
            <p:cNvPr id="9" name="Αντικείμενο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50499986"/>
                </p:ext>
              </p:extLst>
            </p:nvPr>
          </p:nvGraphicFramePr>
          <p:xfrm>
            <a:off x="6174674" y="416859"/>
            <a:ext cx="5877536" cy="4461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8" r:id="rId3" imgW="6374402" imgH="4839390" progId="Prism8.Document">
                    <p:embed/>
                  </p:oleObj>
                </mc:Choice>
                <mc:Fallback>
                  <p:oleObj name="Prism 8" r:id="rId3" imgW="6374402" imgH="4839390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174674" y="416859"/>
                          <a:ext cx="5877536" cy="4461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>
              <a:off x="8919893" y="4439541"/>
              <a:ext cx="109254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200" b="1" dirty="0"/>
                <a:t>Months</a:t>
              </a:r>
              <a:endParaRPr lang="el-GR" sz="2200" b="1" dirty="0"/>
            </a:p>
          </p:txBody>
        </p:sp>
        <p:grpSp>
          <p:nvGrpSpPr>
            <p:cNvPr id="15" name="Ομάδα 14"/>
            <p:cNvGrpSpPr/>
            <p:nvPr/>
          </p:nvGrpSpPr>
          <p:grpSpPr>
            <a:xfrm>
              <a:off x="237222" y="416859"/>
              <a:ext cx="5850841" cy="4462533"/>
              <a:chOff x="237222" y="416859"/>
              <a:chExt cx="5850841" cy="4462533"/>
            </a:xfrm>
          </p:grpSpPr>
          <p:graphicFrame>
            <p:nvGraphicFramePr>
              <p:cNvPr id="8" name="Αντικείμενο 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06266247"/>
                  </p:ext>
                </p:extLst>
              </p:nvPr>
            </p:nvGraphicFramePr>
            <p:xfrm>
              <a:off x="474028" y="416859"/>
              <a:ext cx="5614035" cy="446195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7" name="Prism 8" r:id="rId5" imgW="6087734" imgH="4839390" progId="Prism8.Document">
                      <p:embed/>
                    </p:oleObj>
                  </mc:Choice>
                  <mc:Fallback>
                    <p:oleObj name="Prism 8" r:id="rId5" imgW="6087734" imgH="4839390" progId="Prism8.Document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474028" y="416859"/>
                            <a:ext cx="5614035" cy="446195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>
                <a:off x="2702858" y="4448505"/>
                <a:ext cx="1092543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200" b="1" dirty="0"/>
                  <a:t>Months</a:t>
                </a:r>
                <a:endParaRPr lang="el-GR" sz="2200" b="1" dirty="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-1166271" y="2337848"/>
                <a:ext cx="320709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/>
                  <a:t>Progression free survival (%)</a:t>
                </a:r>
                <a:endParaRPr lang="el-GR" sz="2000" b="1" dirty="0"/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 rot="16200000">
              <a:off x="5291214" y="2248202"/>
              <a:ext cx="229588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/>
                <a:t>Overall survival (%)</a:t>
              </a:r>
              <a:endParaRPr lang="el-GR" sz="2000" b="1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55496" y="5715002"/>
            <a:ext cx="1155102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1: Progression free survival (PFS) and overall survival (OS) post autologous stem cell transplantation according to the presence (con+) or absence (con-) of APC contamination in the apheresis product.</a:t>
            </a:r>
          </a:p>
          <a:p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3897101920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5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Θέμα του Offic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Ioannis</dc:creator>
  <cp:lastModifiedBy>MDPI</cp:lastModifiedBy>
  <cp:revision>4</cp:revision>
  <dcterms:created xsi:type="dcterms:W3CDTF">2021-06-30T13:43:09Z</dcterms:created>
  <dcterms:modified xsi:type="dcterms:W3CDTF">2021-08-09T09:13:57Z</dcterms:modified>
</cp:coreProperties>
</file>